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648"/>
    <p:restoredTop sz="94676"/>
  </p:normalViewPr>
  <p:slideViewPr>
    <p:cSldViewPr snapToGrid="0">
      <p:cViewPr varScale="1">
        <p:scale>
          <a:sx n="93" d="100"/>
          <a:sy n="93" d="100"/>
        </p:scale>
        <p:origin x="768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var/folders/50/90s1076562j9_p0j7wn8rb_c0000gp/T/com.microsoft.Outlook/Outlook%20Temp/DeltaFigur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Ark1'!$B$2</c:f>
              <c:strCache>
                <c:ptCount val="1"/>
                <c:pt idx="0">
                  <c:v>Crude RR for Apgar &lt;7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Ark1'!$E$3:$E$11</c:f>
                <c:numCache>
                  <c:formatCode>General</c:formatCode>
                  <c:ptCount val="9"/>
                  <c:pt idx="0">
                    <c:v>0.39162376069541338</c:v>
                  </c:pt>
                  <c:pt idx="1">
                    <c:v>0.42753908506184901</c:v>
                  </c:pt>
                  <c:pt idx="2">
                    <c:v>0.40781192349518225</c:v>
                  </c:pt>
                  <c:pt idx="3">
                    <c:v>0.3270083636428931</c:v>
                  </c:pt>
                  <c:pt idx="4">
                    <c:v>0</c:v>
                  </c:pt>
                  <c:pt idx="5">
                    <c:v>0.2800795614403323</c:v>
                  </c:pt>
                  <c:pt idx="6">
                    <c:v>0.23964074665267299</c:v>
                  </c:pt>
                  <c:pt idx="7">
                    <c:v>0.25185187261312059</c:v>
                  </c:pt>
                  <c:pt idx="8">
                    <c:v>0.41012838757338477</c:v>
                  </c:pt>
                </c:numCache>
              </c:numRef>
            </c:plus>
            <c:minus>
              <c:numRef>
                <c:f>'Ark1'!$D$3:$D$11</c:f>
                <c:numCache>
                  <c:formatCode>General</c:formatCode>
                  <c:ptCount val="9"/>
                  <c:pt idx="0">
                    <c:v>0.31191312587318465</c:v>
                  </c:pt>
                  <c:pt idx="1">
                    <c:v>0.35496505421185032</c:v>
                  </c:pt>
                  <c:pt idx="2">
                    <c:v>0.32553027897232534</c:v>
                  </c:pt>
                  <c:pt idx="3">
                    <c:v>0.25807862697850892</c:v>
                  </c:pt>
                  <c:pt idx="4">
                    <c:v>0</c:v>
                  </c:pt>
                  <c:pt idx="5">
                    <c:v>0.21162893236314106</c:v>
                  </c:pt>
                  <c:pt idx="6">
                    <c:v>0.19120793664803926</c:v>
                  </c:pt>
                  <c:pt idx="7">
                    <c:v>0.20005906857362876</c:v>
                  </c:pt>
                  <c:pt idx="8">
                    <c:v>0.3412290506427195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Ark1'!$A$3:$A$11</c:f>
              <c:strCache>
                <c:ptCount val="9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 to 6</c:v>
                </c:pt>
                <c:pt idx="5">
                  <c:v>7</c:v>
                </c:pt>
                <c:pt idx="6">
                  <c:v>8</c:v>
                </c:pt>
                <c:pt idx="7">
                  <c:v>9</c:v>
                </c:pt>
                <c:pt idx="8">
                  <c:v>10</c:v>
                </c:pt>
              </c:strCache>
            </c:strRef>
          </c:cat>
          <c:val>
            <c:numRef>
              <c:f>'Ark1'!$B$3:$B$11</c:f>
              <c:numCache>
                <c:formatCode>General</c:formatCode>
                <c:ptCount val="9"/>
                <c:pt idx="0">
                  <c:v>1.532450364209798</c:v>
                </c:pt>
                <c:pt idx="1">
                  <c:v>2.0911258852403409</c:v>
                </c:pt>
                <c:pt idx="2">
                  <c:v>1.6134233824987452</c:v>
                </c:pt>
                <c:pt idx="3">
                  <c:v>1.2243463211002408</c:v>
                </c:pt>
                <c:pt idx="4">
                  <c:v>1</c:v>
                </c:pt>
                <c:pt idx="5">
                  <c:v>0.86592248111427128</c:v>
                </c:pt>
                <c:pt idx="6">
                  <c:v>0.94607793146565988</c:v>
                </c:pt>
                <c:pt idx="7">
                  <c:v>0.9728233871077262</c:v>
                </c:pt>
                <c:pt idx="8">
                  <c:v>2.031191105280555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F20-A140-9F97-693FDDFAA738}"/>
            </c:ext>
          </c:extLst>
        </c:ser>
        <c:ser>
          <c:idx val="1"/>
          <c:order val="1"/>
          <c:tx>
            <c:strRef>
              <c:f>'Ark1'!$C$2</c:f>
              <c:strCache>
                <c:ptCount val="1"/>
                <c:pt idx="0">
                  <c:v>Adjusted for UApH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Ark1'!$H$3:$H$11</c:f>
                <c:numCache>
                  <c:formatCode>General</c:formatCode>
                  <c:ptCount val="9"/>
                  <c:pt idx="0">
                    <c:v>0.4872006306048613</c:v>
                  </c:pt>
                  <c:pt idx="1">
                    <c:v>0.45562272088617783</c:v>
                  </c:pt>
                  <c:pt idx="2">
                    <c:v>0.43878934676879533</c:v>
                  </c:pt>
                  <c:pt idx="3">
                    <c:v>0.35410676041103106</c:v>
                  </c:pt>
                  <c:pt idx="4">
                    <c:v>0</c:v>
                  </c:pt>
                  <c:pt idx="5">
                    <c:v>0.24563514634248895</c:v>
                  </c:pt>
                  <c:pt idx="6">
                    <c:v>0.18921541674785503</c:v>
                  </c:pt>
                  <c:pt idx="7">
                    <c:v>0.1661607683029056</c:v>
                  </c:pt>
                  <c:pt idx="8">
                    <c:v>0.17052814018886719</c:v>
                  </c:pt>
                </c:numCache>
              </c:numRef>
            </c:plus>
            <c:minus>
              <c:numRef>
                <c:f>'Ark1'!$G$3:$G$11</c:f>
                <c:numCache>
                  <c:formatCode>General</c:formatCode>
                  <c:ptCount val="9"/>
                  <c:pt idx="0">
                    <c:v>0.38904318803616444</c:v>
                  </c:pt>
                  <c:pt idx="1">
                    <c:v>0.3766704708891444</c:v>
                  </c:pt>
                  <c:pt idx="2">
                    <c:v>0.35154674992269119</c:v>
                  </c:pt>
                  <c:pt idx="3">
                    <c:v>0.28088836268956108</c:v>
                  </c:pt>
                  <c:pt idx="4">
                    <c:v>0</c:v>
                  </c:pt>
                  <c:pt idx="5">
                    <c:v>0.18662819418502319</c:v>
                  </c:pt>
                  <c:pt idx="6">
                    <c:v>0.15155732244036035</c:v>
                  </c:pt>
                  <c:pt idx="7">
                    <c:v>0.13280880375382875</c:v>
                  </c:pt>
                  <c:pt idx="8">
                    <c:v>0.141668863429725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Ark1'!$A$3:$A$11</c:f>
              <c:strCache>
                <c:ptCount val="9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 to 6</c:v>
                </c:pt>
                <c:pt idx="5">
                  <c:v>7</c:v>
                </c:pt>
                <c:pt idx="6">
                  <c:v>8</c:v>
                </c:pt>
                <c:pt idx="7">
                  <c:v>9</c:v>
                </c:pt>
                <c:pt idx="8">
                  <c:v>10</c:v>
                </c:pt>
              </c:strCache>
            </c:strRef>
          </c:cat>
          <c:val>
            <c:numRef>
              <c:f>'Ark1'!$C$3:$C$11</c:f>
              <c:numCache>
                <c:formatCode>General</c:formatCode>
                <c:ptCount val="9"/>
                <c:pt idx="0">
                  <c:v>1.931000661626765</c:v>
                </c:pt>
                <c:pt idx="1">
                  <c:v>2.1737141731924936</c:v>
                </c:pt>
                <c:pt idx="2">
                  <c:v>1.7681152823703359</c:v>
                </c:pt>
                <c:pt idx="3">
                  <c:v>1.3584627804548774</c:v>
                </c:pt>
                <c:pt idx="4">
                  <c:v>1</c:v>
                </c:pt>
                <c:pt idx="5">
                  <c:v>0.77689902823548052</c:v>
                </c:pt>
                <c:pt idx="6">
                  <c:v>0.76150911123069054</c:v>
                </c:pt>
                <c:pt idx="7">
                  <c:v>0.6616585609718405</c:v>
                </c:pt>
                <c:pt idx="8">
                  <c:v>0.8371148038451439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F20-A140-9F97-693FDDFAA73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63764272"/>
        <c:axId val="1663762608"/>
      </c:barChart>
      <c:catAx>
        <c:axId val="166376427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sv-SE" sz="120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elta decentile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S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SE"/>
          </a:p>
        </c:txPr>
        <c:crossAx val="1663762608"/>
        <c:crosses val="autoZero"/>
        <c:auto val="1"/>
        <c:lblAlgn val="ctr"/>
        <c:lblOffset val="100"/>
        <c:noMultiLvlLbl val="0"/>
      </c:catAx>
      <c:valAx>
        <c:axId val="166376260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</a:t>
                </a:r>
                <a:r>
                  <a:rPr lang="en-US" sz="1200" b="1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Risk </a:t>
                </a:r>
                <a:endParaRPr lang="en-US" sz="12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S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SE"/>
          </a:p>
        </c:txPr>
        <c:crossAx val="166376427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egendEntry>
        <c:idx val="0"/>
        <c:txPr>
          <a:bodyPr rot="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SE"/>
          </a:p>
        </c:txPr>
      </c:legendEntry>
      <c:legendEntry>
        <c:idx val="1"/>
        <c:txPr>
          <a:bodyPr rot="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SE"/>
          </a:p>
        </c:txPr>
      </c:legendEntry>
      <c:layout>
        <c:manualLayout>
          <c:xMode val="edge"/>
          <c:yMode val="edge"/>
          <c:x val="0.25254843675937988"/>
          <c:y val="0.9423016914552349"/>
          <c:w val="0.51651507973711175"/>
          <c:h val="4.658719743365412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SE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S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E30CB5-4EB5-B078-7444-5FBFBF089BA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46C75AF-8584-DB74-5B77-BAFB5B7395D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45FA01-CAF2-7AA7-249C-35D98DCD37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9298F-40C6-804B-96F7-117CA49C8C50}" type="datetimeFigureOut">
              <a:rPr lang="en-SE" smtClean="0"/>
              <a:t>2023-01-08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7275E78-A73D-EB03-B3B7-CE59E53A02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A3FD9A-8970-9DF1-B8C0-0045D0A1E1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02A0B-E77C-F746-A125-9D1507655838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4756298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8BDC59-31F2-C42D-7FBB-83E9C5C7CC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C11F22C-FBC2-A15B-1BD6-501D082C651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DB0022-C5E0-B574-F1C7-9E2415E747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9298F-40C6-804B-96F7-117CA49C8C50}" type="datetimeFigureOut">
              <a:rPr lang="en-SE" smtClean="0"/>
              <a:t>2023-01-08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0FAC14-DDF5-C581-71AC-749847E9CC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E8B45C-B641-4119-37A9-CC6E877AF9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02A0B-E77C-F746-A125-9D1507655838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6069142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AF3FBBF-C0AB-965C-1D87-9F0EAA9F2E9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D9B8797-797B-0E21-A3CA-5FDD5A98795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8E0549-E391-2F0C-14A8-8C0653535C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9298F-40C6-804B-96F7-117CA49C8C50}" type="datetimeFigureOut">
              <a:rPr lang="en-SE" smtClean="0"/>
              <a:t>2023-01-08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A8D744-1505-E73B-F5C1-627F352F9B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5467D1-BD28-767C-94E2-E14FA0F1D9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02A0B-E77C-F746-A125-9D1507655838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688317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C88EF5-F34A-60A1-CC8B-E0E9BAEF44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258E4B1-F786-7535-A7C7-5C983C0AFA8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5BC5A4-42FD-CBF6-DA0F-6892B598E0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9298F-40C6-804B-96F7-117CA49C8C50}" type="datetimeFigureOut">
              <a:rPr lang="en-SE" smtClean="0"/>
              <a:t>2023-01-08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9A89DF-140E-653C-4403-A8010F63D7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49C38F-EE53-9C92-C4EA-EC916CED6F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02A0B-E77C-F746-A125-9D1507655838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7405628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E247C7-E193-E7D3-CD15-E20A497FF6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4C11716-B257-17BB-5DF3-2FA922E922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6FE6CD-F261-E21B-A3E8-1356B7E503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9298F-40C6-804B-96F7-117CA49C8C50}" type="datetimeFigureOut">
              <a:rPr lang="en-SE" smtClean="0"/>
              <a:t>2023-01-08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59C57D-9616-AD81-45AE-AF2DAAC9F4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52E870A-B740-A15D-7D71-0724777C1F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02A0B-E77C-F746-A125-9D1507655838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0090707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DF18B3-3F4B-77AB-ADBF-0A91EEA3DD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726F92A-04AB-06EA-DF82-D83F209125C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3AB8302-C179-B199-1673-C54C2579C6B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30F6578-BAAD-DD29-249A-D171BC5CEF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9298F-40C6-804B-96F7-117CA49C8C50}" type="datetimeFigureOut">
              <a:rPr lang="en-SE" smtClean="0"/>
              <a:t>2023-01-08</a:t>
            </a:fld>
            <a:endParaRPr lang="en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88AE551-DA5A-FA49-0C01-9353A08C85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C0922FA-F6DD-D177-5A30-A8D508120D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02A0B-E77C-F746-A125-9D1507655838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4388326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1DD2E2-09A2-0F38-EDDE-2A8191CE16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C40B1AF-C727-56E8-37D7-FDC2861C77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E78F00A-04DF-AED6-EF87-1E925BE6BD9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3A7BD5D-3DD6-9A35-97AC-E6D2668BF64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2ED349B-C5DD-10C2-2B84-C0C36B9B58A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2D1742D-8EAD-4292-CDBE-6EC1E5B113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9298F-40C6-804B-96F7-117CA49C8C50}" type="datetimeFigureOut">
              <a:rPr lang="en-SE" smtClean="0"/>
              <a:t>2023-01-08</a:t>
            </a:fld>
            <a:endParaRPr lang="en-S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5D0C2A2-38B6-981E-9D62-1272154CBA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EF0217B-B1E9-0778-B969-8E404EB427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02A0B-E77C-F746-A125-9D1507655838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5614695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18A648-A3E0-71D7-7D40-ABC2AC0B27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4FFC917-1134-429C-B389-46299859D7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9298F-40C6-804B-96F7-117CA49C8C50}" type="datetimeFigureOut">
              <a:rPr lang="en-SE" smtClean="0"/>
              <a:t>2023-01-08</a:t>
            </a:fld>
            <a:endParaRPr lang="en-S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F3CADB0-4D3C-F2A4-E9FF-3B8B5B5ECF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0FF1D57-A202-CB86-704B-1FC8088898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02A0B-E77C-F746-A125-9D1507655838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8692250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2BBC79C-560D-2096-7DC7-B4CCC7DAA2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9298F-40C6-804B-96F7-117CA49C8C50}" type="datetimeFigureOut">
              <a:rPr lang="en-SE" smtClean="0"/>
              <a:t>2023-01-08</a:t>
            </a:fld>
            <a:endParaRPr lang="en-S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06CE3E6-AC85-E6FB-6CFF-A03EBF37C7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73201AB-2F2A-4ECF-D75A-D6BDBE27E1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02A0B-E77C-F746-A125-9D1507655838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707480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CE9A6A-6A20-4A8B-F031-4B403EEE74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4184EDC-6D62-AB8D-A7B7-9DCACB2ABE8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D664CF7-5ABA-0C8B-53B0-A1858807203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DFC04CA-5A9A-20C9-D8A0-50B302C606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9298F-40C6-804B-96F7-117CA49C8C50}" type="datetimeFigureOut">
              <a:rPr lang="en-SE" smtClean="0"/>
              <a:t>2023-01-08</a:t>
            </a:fld>
            <a:endParaRPr lang="en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C737B6A-D0CB-CD90-1424-AB25F8D442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808AA2B-F6C9-E9EE-CD6A-FD57344B9B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02A0B-E77C-F746-A125-9D1507655838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7883032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87143A-38BD-6274-DAA5-CC70102035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C541CCF-44D8-0697-7846-9FEF42B9CE1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B36A184-C8F3-BF7B-3EAE-B520EE27224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2062E89-385A-C876-65FB-76F2E3FC49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9298F-40C6-804B-96F7-117CA49C8C50}" type="datetimeFigureOut">
              <a:rPr lang="en-SE" smtClean="0"/>
              <a:t>2023-01-08</a:t>
            </a:fld>
            <a:endParaRPr lang="en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28BE2D1-2534-EA31-0DCA-DB22C91FC3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0225F82-3AE1-D114-77CE-BA4CB2AE85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02A0B-E77C-F746-A125-9D1507655838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2381876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1C2A0F3-0339-B5B7-17A3-A63341CB41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746D996-F7C1-B6B2-AFF2-03C3ECF565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F34295-E280-2D07-780C-74C5A74654E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C9298F-40C6-804B-96F7-117CA49C8C50}" type="datetimeFigureOut">
              <a:rPr lang="en-SE" smtClean="0"/>
              <a:t>2023-01-08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C5351C-EF9C-AD08-7292-FC808212CCB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CE12F8-3236-C675-1523-F972457D8DA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E02A0B-E77C-F746-A125-9D1507655838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5141233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Diagram 1">
            <a:extLst>
              <a:ext uri="{FF2B5EF4-FFF2-40B4-BE49-F238E27FC236}">
                <a16:creationId xmlns:a16="http://schemas.microsoft.com/office/drawing/2014/main" id="{9DEBFC00-8DDB-5639-F17C-F0CF1DF5975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4380923"/>
              </p:ext>
            </p:extLst>
          </p:nvPr>
        </p:nvGraphicFramePr>
        <p:xfrm>
          <a:off x="2276354" y="249382"/>
          <a:ext cx="7639291" cy="556952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EF2B1A0C-66B6-1E95-B9FE-EC946F75E13A}"/>
              </a:ext>
            </a:extLst>
          </p:cNvPr>
          <p:cNvSpPr txBox="1"/>
          <p:nvPr/>
        </p:nvSpPr>
        <p:spPr>
          <a:xfrm>
            <a:off x="2406481" y="6059269"/>
            <a:ext cx="750916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rtl="0">
              <a:defRPr sz="1400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sv-SE" sz="1800" b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rrelation</a:t>
            </a:r>
            <a:r>
              <a:rPr lang="sv-SE" sz="18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SE" sz="1800" b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sv-SE" sz="18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l-GR" sz="18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sv-SE" sz="18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H </a:t>
            </a:r>
            <a:r>
              <a:rPr lang="sv-SE" sz="1800" b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centiles</a:t>
            </a:r>
            <a:r>
              <a:rPr lang="sv-SE" sz="18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to relative risk </a:t>
            </a:r>
            <a:r>
              <a:rPr lang="sv-SE" sz="1800" b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sv-SE" sz="18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5-minute </a:t>
            </a:r>
            <a:r>
              <a:rPr lang="sv-SE" sz="1800" b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pgar</a:t>
            </a:r>
            <a:r>
              <a:rPr lang="sv-SE" sz="18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score 0-6</a:t>
            </a:r>
          </a:p>
        </p:txBody>
      </p:sp>
    </p:spTree>
    <p:extLst>
      <p:ext uri="{BB962C8B-B14F-4D97-AF65-F5344CB8AC3E}">
        <p14:creationId xmlns:p14="http://schemas.microsoft.com/office/powerpoint/2010/main" val="3690621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17</Words>
  <Application>Microsoft Macintosh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hreen Zaigham</dc:creator>
  <cp:lastModifiedBy>Mehreen Zaigham</cp:lastModifiedBy>
  <cp:revision>5</cp:revision>
  <dcterms:created xsi:type="dcterms:W3CDTF">2022-11-15T04:03:46Z</dcterms:created>
  <dcterms:modified xsi:type="dcterms:W3CDTF">2023-01-08T14:49:42Z</dcterms:modified>
</cp:coreProperties>
</file>